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2" d="100"/>
          <a:sy n="92" d="100"/>
        </p:scale>
        <p:origin x="49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7597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0223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5791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0090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68908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3063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742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954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6425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0991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2452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4FDFF6-2B38-45FA-AE27-CEE7F9649448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7A1B6F-289D-451A-8D5F-F26393DB9E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1272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/>
          <p:cNvSpPr txBox="1"/>
          <p:nvPr/>
        </p:nvSpPr>
        <p:spPr>
          <a:xfrm>
            <a:off x="528861" y="204576"/>
            <a:ext cx="109840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. Fruits of the two parents used to generate the IL population and the corresponding F1. From left to right: the cultiva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dranta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VED)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l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p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l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talupens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renta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) used as recurrent parent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nse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kuw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AK)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l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p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rest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kuw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ed as donor parent, and their F1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upo 2"/>
          <p:cNvGrpSpPr/>
          <p:nvPr/>
        </p:nvGrpSpPr>
        <p:grpSpPr>
          <a:xfrm>
            <a:off x="528861" y="1617104"/>
            <a:ext cx="11084984" cy="2345295"/>
            <a:chOff x="528861" y="1617104"/>
            <a:chExt cx="11084984" cy="2345295"/>
          </a:xfrm>
        </p:grpSpPr>
        <p:pic>
          <p:nvPicPr>
            <p:cNvPr id="7" name="Imagen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49" t="750" r="5594" b="23393"/>
            <a:stretch/>
          </p:blipFill>
          <p:spPr>
            <a:xfrm>
              <a:off x="4754240" y="1999864"/>
              <a:ext cx="2943330" cy="1962535"/>
            </a:xfrm>
            <a:prstGeom prst="rect">
              <a:avLst/>
            </a:prstGeom>
          </p:spPr>
        </p:pic>
        <p:pic>
          <p:nvPicPr>
            <p:cNvPr id="8" name="Imagen 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41" t="6699" r="10516" b="37489"/>
            <a:stretch/>
          </p:blipFill>
          <p:spPr>
            <a:xfrm>
              <a:off x="7697570" y="1998482"/>
              <a:ext cx="3916275" cy="1963917"/>
            </a:xfrm>
            <a:prstGeom prst="rect">
              <a:avLst/>
            </a:prstGeom>
          </p:spPr>
        </p:pic>
        <p:pic>
          <p:nvPicPr>
            <p:cNvPr id="9" name="Imagen 8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8" t="8348" b="30835"/>
            <a:stretch/>
          </p:blipFill>
          <p:spPr>
            <a:xfrm>
              <a:off x="528861" y="1998481"/>
              <a:ext cx="4234141" cy="1963917"/>
            </a:xfrm>
            <a:prstGeom prst="rect">
              <a:avLst/>
            </a:prstGeom>
          </p:spPr>
        </p:pic>
        <p:grpSp>
          <p:nvGrpSpPr>
            <p:cNvPr id="11" name="Grupo 10"/>
            <p:cNvGrpSpPr/>
            <p:nvPr/>
          </p:nvGrpSpPr>
          <p:grpSpPr>
            <a:xfrm>
              <a:off x="2253132" y="2043638"/>
              <a:ext cx="699213" cy="276999"/>
              <a:chOff x="4363536" y="2068510"/>
              <a:chExt cx="526409" cy="276999"/>
            </a:xfrm>
          </p:grpSpPr>
          <p:cxnSp>
            <p:nvCxnSpPr>
              <p:cNvPr id="12" name="Conector recto 11"/>
              <p:cNvCxnSpPr/>
              <p:nvPr/>
            </p:nvCxnSpPr>
            <p:spPr>
              <a:xfrm>
                <a:off x="4363536" y="2316796"/>
                <a:ext cx="454831" cy="4738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CuadroTexto 12"/>
              <p:cNvSpPr txBox="1"/>
              <p:nvPr/>
            </p:nvSpPr>
            <p:spPr>
              <a:xfrm>
                <a:off x="4411177" y="2068510"/>
                <a:ext cx="4787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/>
                  <a:t>5</a:t>
                </a:r>
                <a:r>
                  <a:rPr lang="es-ES" sz="600" dirty="0" smtClean="0"/>
                  <a:t> </a:t>
                </a:r>
                <a:r>
                  <a:rPr lang="es-ES" sz="1200" dirty="0" smtClean="0"/>
                  <a:t>cm</a:t>
                </a:r>
                <a:endParaRPr lang="es-ES" sz="1200" dirty="0"/>
              </a:p>
            </p:txBody>
          </p:sp>
        </p:grpSp>
        <p:grpSp>
          <p:nvGrpSpPr>
            <p:cNvPr id="14" name="Grupo 13"/>
            <p:cNvGrpSpPr/>
            <p:nvPr/>
          </p:nvGrpSpPr>
          <p:grpSpPr>
            <a:xfrm>
              <a:off x="5817244" y="2014925"/>
              <a:ext cx="699213" cy="276999"/>
              <a:chOff x="4363536" y="2068510"/>
              <a:chExt cx="526409" cy="276999"/>
            </a:xfrm>
          </p:grpSpPr>
          <p:cxnSp>
            <p:nvCxnSpPr>
              <p:cNvPr id="15" name="Conector recto 14"/>
              <p:cNvCxnSpPr/>
              <p:nvPr/>
            </p:nvCxnSpPr>
            <p:spPr>
              <a:xfrm>
                <a:off x="4363536" y="2316796"/>
                <a:ext cx="454831" cy="4738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CuadroTexto 15"/>
              <p:cNvSpPr txBox="1"/>
              <p:nvPr/>
            </p:nvSpPr>
            <p:spPr>
              <a:xfrm>
                <a:off x="4411177" y="2068510"/>
                <a:ext cx="4787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/>
                  <a:t>5</a:t>
                </a:r>
                <a:r>
                  <a:rPr lang="es-ES" sz="600" dirty="0" smtClean="0"/>
                  <a:t> </a:t>
                </a:r>
                <a:r>
                  <a:rPr lang="es-ES" sz="1200" dirty="0" smtClean="0"/>
                  <a:t>cm</a:t>
                </a:r>
                <a:endParaRPr lang="es-ES" sz="1200" dirty="0"/>
              </a:p>
            </p:txBody>
          </p:sp>
        </p:grpSp>
        <p:grpSp>
          <p:nvGrpSpPr>
            <p:cNvPr id="17" name="Grupo 16"/>
            <p:cNvGrpSpPr/>
            <p:nvPr/>
          </p:nvGrpSpPr>
          <p:grpSpPr>
            <a:xfrm>
              <a:off x="9336900" y="2009589"/>
              <a:ext cx="699213" cy="276999"/>
              <a:chOff x="4363536" y="2068510"/>
              <a:chExt cx="526409" cy="276999"/>
            </a:xfrm>
          </p:grpSpPr>
          <p:cxnSp>
            <p:nvCxnSpPr>
              <p:cNvPr id="18" name="Conector recto 17"/>
              <p:cNvCxnSpPr/>
              <p:nvPr/>
            </p:nvCxnSpPr>
            <p:spPr>
              <a:xfrm>
                <a:off x="4363536" y="2316796"/>
                <a:ext cx="454831" cy="4738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CuadroTexto 18"/>
              <p:cNvSpPr txBox="1"/>
              <p:nvPr/>
            </p:nvSpPr>
            <p:spPr>
              <a:xfrm>
                <a:off x="4411177" y="2068510"/>
                <a:ext cx="4787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/>
                  <a:t>5</a:t>
                </a:r>
                <a:r>
                  <a:rPr lang="es-ES" sz="600" dirty="0" smtClean="0"/>
                  <a:t> </a:t>
                </a:r>
                <a:r>
                  <a:rPr lang="es-ES" sz="1200" dirty="0" smtClean="0"/>
                  <a:t>cm</a:t>
                </a:r>
                <a:endParaRPr lang="es-ES" sz="1200" dirty="0"/>
              </a:p>
            </p:txBody>
          </p:sp>
        </p:grpSp>
        <p:sp>
          <p:nvSpPr>
            <p:cNvPr id="20" name="CuadroTexto 19"/>
            <p:cNvSpPr txBox="1"/>
            <p:nvPr/>
          </p:nvSpPr>
          <p:spPr>
            <a:xfrm>
              <a:off x="2250943" y="1630823"/>
              <a:ext cx="570990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VED</a:t>
              </a:r>
              <a:endParaRPr lang="es-ES" dirty="0"/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5817244" y="1617104"/>
              <a:ext cx="635110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MAK</a:t>
              </a:r>
              <a:endParaRPr lang="es-ES" dirty="0"/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9451965" y="1617104"/>
              <a:ext cx="407484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F1</a:t>
              </a:r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4015457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84</Words>
  <Application>Microsoft Office PowerPoint</Application>
  <PresentationFormat>Panorámica</PresentationFormat>
  <Paragraphs>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orka Perpiña Martin</dc:creator>
  <cp:lastModifiedBy>Usuario</cp:lastModifiedBy>
  <cp:revision>14</cp:revision>
  <dcterms:created xsi:type="dcterms:W3CDTF">2016-01-18T11:22:01Z</dcterms:created>
  <dcterms:modified xsi:type="dcterms:W3CDTF">2016-06-15T19:08:38Z</dcterms:modified>
</cp:coreProperties>
</file>